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7" d="100"/>
          <a:sy n="77" d="100"/>
        </p:scale>
        <p:origin x="806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tanislas Bataille" userId="a31c709071a4ef82" providerId="LiveId" clId="{15C67FFD-4DC4-423E-862B-459232E3CA6B}"/>
    <pc:docChg chg="addSld modSld">
      <pc:chgData name="Stanislas Bataille" userId="a31c709071a4ef82" providerId="LiveId" clId="{15C67FFD-4DC4-423E-862B-459232E3CA6B}" dt="2025-03-17T09:52:25.053" v="1"/>
      <pc:docMkLst>
        <pc:docMk/>
      </pc:docMkLst>
      <pc:sldChg chg="add">
        <pc:chgData name="Stanislas Bataille" userId="a31c709071a4ef82" providerId="LiveId" clId="{15C67FFD-4DC4-423E-862B-459232E3CA6B}" dt="2025-03-17T09:15:27.932" v="0"/>
        <pc:sldMkLst>
          <pc:docMk/>
          <pc:sldMk cId="156984254" sldId="257"/>
        </pc:sldMkLst>
      </pc:sldChg>
      <pc:sldChg chg="add">
        <pc:chgData name="Stanislas Bataille" userId="a31c709071a4ef82" providerId="LiveId" clId="{15C67FFD-4DC4-423E-862B-459232E3CA6B}" dt="2025-03-17T09:52:25.053" v="1"/>
        <pc:sldMkLst>
          <pc:docMk/>
          <pc:sldMk cId="3648754909" sldId="259"/>
        </pc:sldMkLst>
      </pc:sldChg>
      <pc:sldChg chg="add">
        <pc:chgData name="Stanislas Bataille" userId="a31c709071a4ef82" providerId="LiveId" clId="{15C67FFD-4DC4-423E-862B-459232E3CA6B}" dt="2025-03-17T09:52:25.053" v="1"/>
        <pc:sldMkLst>
          <pc:docMk/>
          <pc:sldMk cId="183903091" sldId="298"/>
        </pc:sldMkLst>
      </pc:sldChg>
    </pc:docChg>
  </pc:docChgLst>
  <pc:docChgLst>
    <pc:chgData name="Stanislas Bataille" userId="a31c709071a4ef82" providerId="LiveId" clId="{C12CDAFC-CA36-4066-8037-1E8B12997EF4}"/>
    <pc:docChg chg="undo custSel delSld modSld">
      <pc:chgData name="Stanislas Bataille" userId="a31c709071a4ef82" providerId="LiveId" clId="{C12CDAFC-CA36-4066-8037-1E8B12997EF4}" dt="2025-06-07T15:45:17.888" v="419" actId="20577"/>
      <pc:docMkLst>
        <pc:docMk/>
      </pc:docMkLst>
      <pc:sldChg chg="del">
        <pc:chgData name="Stanislas Bataille" userId="a31c709071a4ef82" providerId="LiveId" clId="{C12CDAFC-CA36-4066-8037-1E8B12997EF4}" dt="2025-06-07T15:44:58.638" v="399" actId="47"/>
        <pc:sldMkLst>
          <pc:docMk/>
          <pc:sldMk cId="2150479633" sldId="256"/>
        </pc:sldMkLst>
      </pc:sldChg>
      <pc:sldChg chg="addSp delSp modSp mod">
        <pc:chgData name="Stanislas Bataille" userId="a31c709071a4ef82" providerId="LiveId" clId="{C12CDAFC-CA36-4066-8037-1E8B12997EF4}" dt="2025-06-07T15:45:17.888" v="419" actId="20577"/>
        <pc:sldMkLst>
          <pc:docMk/>
          <pc:sldMk cId="156984254" sldId="257"/>
        </pc:sldMkLst>
      </pc:sldChg>
      <pc:sldChg chg="del">
        <pc:chgData name="Stanislas Bataille" userId="a31c709071a4ef82" providerId="LiveId" clId="{C12CDAFC-CA36-4066-8037-1E8B12997EF4}" dt="2025-06-07T15:45:00.976" v="400" actId="47"/>
        <pc:sldMkLst>
          <pc:docMk/>
          <pc:sldMk cId="3648754909" sldId="259"/>
        </pc:sldMkLst>
      </pc:sldChg>
      <pc:sldChg chg="del">
        <pc:chgData name="Stanislas Bataille" userId="a31c709071a4ef82" providerId="LiveId" clId="{C12CDAFC-CA36-4066-8037-1E8B12997EF4}" dt="2025-06-07T15:45:03.379" v="401" actId="47"/>
        <pc:sldMkLst>
          <pc:docMk/>
          <pc:sldMk cId="183903091" sldId="298"/>
        </pc:sldMkLst>
      </pc:sldChg>
    </pc:docChg>
  </pc:docChgLst>
  <pc:docChgLst>
    <pc:chgData name="Stanislas Bataille" userId="a31c709071a4ef82" providerId="LiveId" clId="{9F2A39EB-0EC7-42C8-803B-E1860A25A75B}"/>
    <pc:docChg chg="modSld">
      <pc:chgData name="Stanislas Bataille" userId="a31c709071a4ef82" providerId="LiveId" clId="{9F2A39EB-0EC7-42C8-803B-E1860A25A75B}" dt="2025-09-03T09:08:19.877" v="7" actId="20577"/>
      <pc:docMkLst>
        <pc:docMk/>
      </pc:docMkLst>
      <pc:sldChg chg="modSp mod">
        <pc:chgData name="Stanislas Bataille" userId="a31c709071a4ef82" providerId="LiveId" clId="{9F2A39EB-0EC7-42C8-803B-E1860A25A75B}" dt="2025-09-03T09:08:19.877" v="7" actId="20577"/>
        <pc:sldMkLst>
          <pc:docMk/>
          <pc:sldMk cId="156984254" sldId="257"/>
        </pc:sldMkLst>
        <pc:graphicFrameChg chg="modGraphic">
          <ac:chgData name="Stanislas Bataille" userId="a31c709071a4ef82" providerId="LiveId" clId="{9F2A39EB-0EC7-42C8-803B-E1860A25A75B}" dt="2025-09-03T09:08:19.877" v="7" actId="20577"/>
          <ac:graphicFrameMkLst>
            <pc:docMk/>
            <pc:sldMk cId="156984254" sldId="257"/>
            <ac:graphicFrameMk id="3" creationId="{42ECFE3B-7FDF-6BDB-2467-76359EEC3E5E}"/>
          </ac:graphicFrameMkLst>
        </pc:graphicFrameChg>
      </pc:sldChg>
    </pc:docChg>
  </pc:docChgLst>
  <pc:docChgLst>
    <pc:chgData name="Stanislas Bataille" userId="a31c709071a4ef82" providerId="LiveId" clId="{0B7EC539-7F6D-49E3-94B9-194BFA6BC89C}"/>
    <pc:docChg chg="undo redo custSel modSld">
      <pc:chgData name="Stanislas Bataille" userId="a31c709071a4ef82" providerId="LiveId" clId="{0B7EC539-7F6D-49E3-94B9-194BFA6BC89C}" dt="2025-07-24T09:28:43.305" v="68" actId="27918"/>
      <pc:docMkLst>
        <pc:docMk/>
      </pc:docMkLst>
      <pc:sldChg chg="delSp modSp mod">
        <pc:chgData name="Stanislas Bataille" userId="a31c709071a4ef82" providerId="LiveId" clId="{0B7EC539-7F6D-49E3-94B9-194BFA6BC89C}" dt="2025-07-24T09:28:43.305" v="68" actId="27918"/>
        <pc:sldMkLst>
          <pc:docMk/>
          <pc:sldMk cId="156984254" sldId="257"/>
        </pc:sldMkLst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0549077263779527"/>
          <c:y val="4.4455029253504606E-2"/>
          <c:w val="0.87419672736220477"/>
          <c:h val="0.8082912273442897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Feuil1!$C$1</c:f>
              <c:strCache>
                <c:ptCount val="1"/>
                <c:pt idx="0">
                  <c:v>Non randomized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numRef>
              <c:f>Feuil1!$B$2:$B$11</c:f>
              <c:numCache>
                <c:formatCode>General</c:formatCode>
                <c:ptCount val="10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</c:numCache>
            </c:numRef>
          </c:cat>
          <c:val>
            <c:numRef>
              <c:f>Feuil1!$C$2:$C$11</c:f>
              <c:numCache>
                <c:formatCode>General</c:formatCode>
                <c:ptCount val="10"/>
                <c:pt idx="0">
                  <c:v>32</c:v>
                </c:pt>
                <c:pt idx="1">
                  <c:v>25</c:v>
                </c:pt>
                <c:pt idx="2">
                  <c:v>29</c:v>
                </c:pt>
                <c:pt idx="3">
                  <c:v>16</c:v>
                </c:pt>
                <c:pt idx="4">
                  <c:v>4</c:v>
                </c:pt>
                <c:pt idx="5">
                  <c:v>1</c:v>
                </c:pt>
                <c:pt idx="6">
                  <c:v>11</c:v>
                </c:pt>
                <c:pt idx="7">
                  <c:v>5</c:v>
                </c:pt>
                <c:pt idx="8">
                  <c:v>5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C47-4609-8376-87049DD07E34}"/>
            </c:ext>
          </c:extLst>
        </c:ser>
        <c:ser>
          <c:idx val="1"/>
          <c:order val="1"/>
          <c:tx>
            <c:strRef>
              <c:f>Feuil1!$D$1</c:f>
              <c:strCache>
                <c:ptCount val="1"/>
                <c:pt idx="0">
                  <c:v>Cholecalciferol</c:v>
                </c:pt>
              </c:strCache>
            </c:strRef>
          </c:tx>
          <c:spPr>
            <a:solidFill>
              <a:schemeClr val="bg2">
                <a:lumMod val="25000"/>
              </a:schemeClr>
            </a:solidFill>
            <a:ln>
              <a:solidFill>
                <a:schemeClr val="tx1"/>
              </a:solidFill>
            </a:ln>
            <a:effectLst>
              <a:glow rad="127000">
                <a:schemeClr val="bg1"/>
              </a:glow>
              <a:outerShdw blurRad="50800" dist="50800" dir="5400000" algn="ctr" rotWithShape="0">
                <a:schemeClr val="bg1"/>
              </a:outerShdw>
            </a:effectLst>
          </c:spPr>
          <c:invertIfNegative val="0"/>
          <c:cat>
            <c:numRef>
              <c:f>Feuil1!$B$2:$B$11</c:f>
              <c:numCache>
                <c:formatCode>General</c:formatCode>
                <c:ptCount val="10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</c:numCache>
            </c:numRef>
          </c:cat>
          <c:val>
            <c:numRef>
              <c:f>Feuil1!$D$2:$D$11</c:f>
              <c:numCache>
                <c:formatCode>General</c:formatCode>
                <c:ptCount val="10"/>
                <c:pt idx="0">
                  <c:v>21</c:v>
                </c:pt>
                <c:pt idx="1">
                  <c:v>17</c:v>
                </c:pt>
                <c:pt idx="2">
                  <c:v>8</c:v>
                </c:pt>
                <c:pt idx="3">
                  <c:v>5</c:v>
                </c:pt>
                <c:pt idx="4">
                  <c:v>7</c:v>
                </c:pt>
                <c:pt idx="5">
                  <c:v>6</c:v>
                </c:pt>
                <c:pt idx="6">
                  <c:v>1</c:v>
                </c:pt>
                <c:pt idx="7">
                  <c:v>1</c:v>
                </c:pt>
                <c:pt idx="8">
                  <c:v>2</c:v>
                </c:pt>
                <c:pt idx="9">
                  <c:v>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4C47-4609-8376-87049DD07E34}"/>
            </c:ext>
          </c:extLst>
        </c:ser>
        <c:ser>
          <c:idx val="2"/>
          <c:order val="2"/>
          <c:tx>
            <c:strRef>
              <c:f>Feuil1!$E$1</c:f>
              <c:strCache>
                <c:ptCount val="1"/>
                <c:pt idx="0">
                  <c:v>No cholecalciferol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numRef>
              <c:f>Feuil1!$B$2:$B$11</c:f>
              <c:numCache>
                <c:formatCode>General</c:formatCode>
                <c:ptCount val="10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</c:numCache>
            </c:numRef>
          </c:cat>
          <c:val>
            <c:numRef>
              <c:f>Feuil1!$E$2:$E$11</c:f>
              <c:numCache>
                <c:formatCode>General</c:formatCode>
                <c:ptCount val="10"/>
                <c:pt idx="0">
                  <c:v>19</c:v>
                </c:pt>
                <c:pt idx="1">
                  <c:v>19</c:v>
                </c:pt>
                <c:pt idx="2">
                  <c:v>8</c:v>
                </c:pt>
                <c:pt idx="3">
                  <c:v>5</c:v>
                </c:pt>
                <c:pt idx="4">
                  <c:v>10</c:v>
                </c:pt>
                <c:pt idx="5">
                  <c:v>8</c:v>
                </c:pt>
                <c:pt idx="6">
                  <c:v>1</c:v>
                </c:pt>
                <c:pt idx="7">
                  <c:v>0</c:v>
                </c:pt>
                <c:pt idx="8">
                  <c:v>2</c:v>
                </c:pt>
                <c:pt idx="9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A4D-49C6-BD8A-A11F936FF29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45663232"/>
        <c:axId val="245666184"/>
      </c:barChart>
      <c:catAx>
        <c:axId val="24566323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fr-FR"/>
          </a:p>
        </c:txPr>
        <c:crossAx val="245666184"/>
        <c:crosses val="autoZero"/>
        <c:auto val="1"/>
        <c:lblAlgn val="ctr"/>
        <c:lblOffset val="100"/>
        <c:noMultiLvlLbl val="0"/>
      </c:catAx>
      <c:valAx>
        <c:axId val="24566618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8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fr-FR" sz="1800" dirty="0" err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umber</a:t>
                </a:r>
                <a:r>
                  <a:rPr lang="fr-FR" sz="18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of patients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8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fr-FR"/>
            </a:p>
          </c:txPr>
        </c:title>
        <c:numFmt formatCode="General" sourceLinked="1"/>
        <c:majorTickMark val="none"/>
        <c:minorTickMark val="none"/>
        <c:tickLblPos val="low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fr-FR"/>
          </a:p>
        </c:txPr>
        <c:crossAx val="24566323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r le style des sous-titres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40CAED-342F-4781-BE3E-AADBC66429AF}" type="datetimeFigureOut">
              <a:rPr lang="fr-FR" smtClean="0"/>
              <a:t>23/09/202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BF82C1-C7B8-461F-8B0B-F1439B0717D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317701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40CAED-342F-4781-BE3E-AADBC66429AF}" type="datetimeFigureOut">
              <a:rPr lang="fr-FR" smtClean="0"/>
              <a:t>23/09/202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BF82C1-C7B8-461F-8B0B-F1439B0717D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192972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40CAED-342F-4781-BE3E-AADBC66429AF}" type="datetimeFigureOut">
              <a:rPr lang="fr-FR" smtClean="0"/>
              <a:t>23/09/202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BF82C1-C7B8-461F-8B0B-F1439B0717D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899149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40CAED-342F-4781-BE3E-AADBC66429AF}" type="datetimeFigureOut">
              <a:rPr lang="fr-FR" smtClean="0"/>
              <a:t>23/09/202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BF82C1-C7B8-461F-8B0B-F1439B0717D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833391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40CAED-342F-4781-BE3E-AADBC66429AF}" type="datetimeFigureOut">
              <a:rPr lang="fr-FR" smtClean="0"/>
              <a:t>23/09/202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BF82C1-C7B8-461F-8B0B-F1439B0717D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875705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40CAED-342F-4781-BE3E-AADBC66429AF}" type="datetimeFigureOut">
              <a:rPr lang="fr-FR" smtClean="0"/>
              <a:t>23/09/2025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BF82C1-C7B8-461F-8B0B-F1439B0717D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328107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40CAED-342F-4781-BE3E-AADBC66429AF}" type="datetimeFigureOut">
              <a:rPr lang="fr-FR" smtClean="0"/>
              <a:t>23/09/2025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BF82C1-C7B8-461F-8B0B-F1439B0717D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737984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40CAED-342F-4781-BE3E-AADBC66429AF}" type="datetimeFigureOut">
              <a:rPr lang="fr-FR" smtClean="0"/>
              <a:t>23/09/2025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BF82C1-C7B8-461F-8B0B-F1439B0717D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111633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40CAED-342F-4781-BE3E-AADBC66429AF}" type="datetimeFigureOut">
              <a:rPr lang="fr-FR" smtClean="0"/>
              <a:t>23/09/2025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BF82C1-C7B8-461F-8B0B-F1439B0717D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435059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40CAED-342F-4781-BE3E-AADBC66429AF}" type="datetimeFigureOut">
              <a:rPr lang="fr-FR" smtClean="0"/>
              <a:t>23/09/2025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BF82C1-C7B8-461F-8B0B-F1439B0717D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963122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40CAED-342F-4781-BE3E-AADBC66429AF}" type="datetimeFigureOut">
              <a:rPr lang="fr-FR" smtClean="0"/>
              <a:t>23/09/2025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BF82C1-C7B8-461F-8B0B-F1439B0717D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95166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40CAED-342F-4781-BE3E-AADBC66429AF}" type="datetimeFigureOut">
              <a:rPr lang="fr-FR" smtClean="0"/>
              <a:t>23/09/202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BF82C1-C7B8-461F-8B0B-F1439B0717D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788841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D58A355-5DD6-735F-69B8-108D51931C6B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Graphique 5">
            <a:extLst>
              <a:ext uri="{FF2B5EF4-FFF2-40B4-BE49-F238E27FC236}">
                <a16:creationId xmlns:a16="http://schemas.microsoft.com/office/drawing/2014/main" id="{0D03A2EC-AB4F-C33E-BEA3-4CDDD8F468BB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1377098482"/>
              </p:ext>
            </p:extLst>
          </p:nvPr>
        </p:nvGraphicFramePr>
        <p:xfrm>
          <a:off x="714704" y="127492"/>
          <a:ext cx="8027208" cy="451808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7" name="ZoneTexte 6">
            <a:extLst>
              <a:ext uri="{FF2B5EF4-FFF2-40B4-BE49-F238E27FC236}">
                <a16:creationId xmlns:a16="http://schemas.microsoft.com/office/drawing/2014/main" id="{EE4E2ED6-1B34-1377-69BC-73C3892E5C29}"/>
              </a:ext>
            </a:extLst>
          </p:cNvPr>
          <p:cNvSpPr txBox="1"/>
          <p:nvPr/>
        </p:nvSpPr>
        <p:spPr>
          <a:xfrm>
            <a:off x="8542215" y="629224"/>
            <a:ext cx="3649785" cy="33547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 </a:t>
            </a:r>
            <a:r>
              <a:rPr lang="fr-FR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hocean</a:t>
            </a:r>
            <a:r>
              <a:rPr lang="fr-F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ephrology</a:t>
            </a:r>
            <a:r>
              <a:rPr lang="fr-F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stitute</a:t>
            </a:r>
            <a:r>
              <a:rPr lang="fr-F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Marseille, France</a:t>
            </a:r>
          </a:p>
          <a:p>
            <a:r>
              <a:rPr lang="fr-F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. Association ECHO, Nantes and Le Mans, France</a:t>
            </a:r>
          </a:p>
          <a:p>
            <a:r>
              <a:rPr lang="fr-F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. ATUP-C, Marseille, France</a:t>
            </a:r>
          </a:p>
          <a:p>
            <a:r>
              <a:rPr lang="fr-F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. La Ciotat, Marseille, France</a:t>
            </a:r>
          </a:p>
          <a:p>
            <a:r>
              <a:rPr lang="fr-F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. AP-HM, Marseille, France</a:t>
            </a:r>
          </a:p>
          <a:p>
            <a:r>
              <a:rPr lang="fr-F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. La Louvière, Lille, France</a:t>
            </a:r>
          </a:p>
          <a:p>
            <a:r>
              <a:rPr lang="fr-F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. </a:t>
            </a:r>
            <a:r>
              <a:rPr lang="fr-FR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ephrocare</a:t>
            </a:r>
            <a:r>
              <a:rPr lang="fr-F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Tassin la demi-lune, France</a:t>
            </a:r>
          </a:p>
          <a:p>
            <a:r>
              <a:rPr lang="fr-F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. AURAD aquitaine, Gradignan, France</a:t>
            </a:r>
          </a:p>
          <a:p>
            <a:r>
              <a:rPr lang="fr-F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. Libourne, France</a:t>
            </a:r>
          </a:p>
          <a:p>
            <a:r>
              <a:rPr lang="fr-F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. ATIR, Avignon, France</a:t>
            </a:r>
          </a:p>
        </p:txBody>
      </p:sp>
      <p:graphicFrame>
        <p:nvGraphicFramePr>
          <p:cNvPr id="3" name="Tableau 2">
            <a:extLst>
              <a:ext uri="{FF2B5EF4-FFF2-40B4-BE49-F238E27FC236}">
                <a16:creationId xmlns:a16="http://schemas.microsoft.com/office/drawing/2014/main" id="{42ECFE3B-7FDF-6BDB-2467-76359EEC3E5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75144092"/>
              </p:ext>
            </p:extLst>
          </p:nvPr>
        </p:nvGraphicFramePr>
        <p:xfrm>
          <a:off x="178267" y="4083378"/>
          <a:ext cx="9100082" cy="185420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480595">
                  <a:extLst>
                    <a:ext uri="{9D8B030D-6E8A-4147-A177-3AD203B41FA5}">
                      <a16:colId xmlns:a16="http://schemas.microsoft.com/office/drawing/2014/main" val="3821714238"/>
                    </a:ext>
                  </a:extLst>
                </a:gridCol>
                <a:gridCol w="647159">
                  <a:extLst>
                    <a:ext uri="{9D8B030D-6E8A-4147-A177-3AD203B41FA5}">
                      <a16:colId xmlns:a16="http://schemas.microsoft.com/office/drawing/2014/main" val="3882873754"/>
                    </a:ext>
                  </a:extLst>
                </a:gridCol>
                <a:gridCol w="666059">
                  <a:extLst>
                    <a:ext uri="{9D8B030D-6E8A-4147-A177-3AD203B41FA5}">
                      <a16:colId xmlns:a16="http://schemas.microsoft.com/office/drawing/2014/main" val="35630324"/>
                    </a:ext>
                  </a:extLst>
                </a:gridCol>
                <a:gridCol w="729493">
                  <a:extLst>
                    <a:ext uri="{9D8B030D-6E8A-4147-A177-3AD203B41FA5}">
                      <a16:colId xmlns:a16="http://schemas.microsoft.com/office/drawing/2014/main" val="4235898612"/>
                    </a:ext>
                  </a:extLst>
                </a:gridCol>
                <a:gridCol w="729493">
                  <a:extLst>
                    <a:ext uri="{9D8B030D-6E8A-4147-A177-3AD203B41FA5}">
                      <a16:colId xmlns:a16="http://schemas.microsoft.com/office/drawing/2014/main" val="2816601688"/>
                    </a:ext>
                  </a:extLst>
                </a:gridCol>
                <a:gridCol w="729493">
                  <a:extLst>
                    <a:ext uri="{9D8B030D-6E8A-4147-A177-3AD203B41FA5}">
                      <a16:colId xmlns:a16="http://schemas.microsoft.com/office/drawing/2014/main" val="1370746112"/>
                    </a:ext>
                  </a:extLst>
                </a:gridCol>
                <a:gridCol w="718920">
                  <a:extLst>
                    <a:ext uri="{9D8B030D-6E8A-4147-A177-3AD203B41FA5}">
                      <a16:colId xmlns:a16="http://schemas.microsoft.com/office/drawing/2014/main" val="2165850078"/>
                    </a:ext>
                  </a:extLst>
                </a:gridCol>
                <a:gridCol w="740064">
                  <a:extLst>
                    <a:ext uri="{9D8B030D-6E8A-4147-A177-3AD203B41FA5}">
                      <a16:colId xmlns:a16="http://schemas.microsoft.com/office/drawing/2014/main" val="2026498791"/>
                    </a:ext>
                  </a:extLst>
                </a:gridCol>
                <a:gridCol w="687204">
                  <a:extLst>
                    <a:ext uri="{9D8B030D-6E8A-4147-A177-3AD203B41FA5}">
                      <a16:colId xmlns:a16="http://schemas.microsoft.com/office/drawing/2014/main" val="998640010"/>
                    </a:ext>
                  </a:extLst>
                </a:gridCol>
                <a:gridCol w="708348">
                  <a:extLst>
                    <a:ext uri="{9D8B030D-6E8A-4147-A177-3AD203B41FA5}">
                      <a16:colId xmlns:a16="http://schemas.microsoft.com/office/drawing/2014/main" val="1976119003"/>
                    </a:ext>
                  </a:extLst>
                </a:gridCol>
                <a:gridCol w="631627">
                  <a:extLst>
                    <a:ext uri="{9D8B030D-6E8A-4147-A177-3AD203B41FA5}">
                      <a16:colId xmlns:a16="http://schemas.microsoft.com/office/drawing/2014/main" val="1457237842"/>
                    </a:ext>
                  </a:extLst>
                </a:gridCol>
                <a:gridCol w="631627">
                  <a:extLst>
                    <a:ext uri="{9D8B030D-6E8A-4147-A177-3AD203B41FA5}">
                      <a16:colId xmlns:a16="http://schemas.microsoft.com/office/drawing/2014/main" val="3691759232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fr-FR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nter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otal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1120016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fr-FR" sz="1200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cluded</a:t>
                      </a:r>
                      <a:endParaRPr lang="fr-FR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2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1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5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70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2519764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fr-FR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Non </a:t>
                      </a:r>
                      <a:r>
                        <a:rPr lang="fr-FR" sz="1200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ndomized</a:t>
                      </a:r>
                      <a:endParaRPr lang="fr-FR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2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9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7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9748156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fr-FR" sz="1200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olecalciferol</a:t>
                      </a:r>
                      <a:r>
                        <a:rPr lang="fr-FR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0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2894287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fr-FR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No </a:t>
                      </a:r>
                      <a:r>
                        <a:rPr lang="fr-FR" sz="1200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olecalciferol</a:t>
                      </a:r>
                      <a:endParaRPr lang="fr-FR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3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9720210"/>
                  </a:ext>
                </a:extLst>
              </a:tr>
            </a:tbl>
          </a:graphicData>
        </a:graphic>
      </p:graphicFrame>
      <p:sp>
        <p:nvSpPr>
          <p:cNvPr id="4" name="Rectangle 3">
            <a:extLst>
              <a:ext uri="{FF2B5EF4-FFF2-40B4-BE49-F238E27FC236}">
                <a16:creationId xmlns:a16="http://schemas.microsoft.com/office/drawing/2014/main" id="{A973BABF-2FC1-0F7C-4893-94018C5CD867}"/>
              </a:ext>
            </a:extLst>
          </p:cNvPr>
          <p:cNvSpPr/>
          <p:nvPr/>
        </p:nvSpPr>
        <p:spPr>
          <a:xfrm>
            <a:off x="222544" y="4953000"/>
            <a:ext cx="109505" cy="114957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7C30FEFA-9618-0519-DA68-A8C5A07F3AB7}"/>
              </a:ext>
            </a:extLst>
          </p:cNvPr>
          <p:cNvSpPr/>
          <p:nvPr/>
        </p:nvSpPr>
        <p:spPr>
          <a:xfrm>
            <a:off x="222544" y="5333343"/>
            <a:ext cx="109505" cy="114957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1231EB5B-4EDE-A9AD-4002-E49E23CE5C8F}"/>
              </a:ext>
            </a:extLst>
          </p:cNvPr>
          <p:cNvSpPr/>
          <p:nvPr/>
        </p:nvSpPr>
        <p:spPr>
          <a:xfrm>
            <a:off x="222543" y="5693388"/>
            <a:ext cx="109505" cy="114957"/>
          </a:xfrm>
          <a:prstGeom prst="rect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56984254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6</TotalTime>
  <Words>146</Words>
  <Application>Microsoft Office PowerPoint</Application>
  <PresentationFormat>Grand écran</PresentationFormat>
  <Paragraphs>71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Stanislas BATAILLE</dc:creator>
  <cp:lastModifiedBy>Stanislas Bataille</cp:lastModifiedBy>
  <cp:revision>3</cp:revision>
  <dcterms:created xsi:type="dcterms:W3CDTF">2025-03-14T15:40:31Z</dcterms:created>
  <dcterms:modified xsi:type="dcterms:W3CDTF">2025-09-23T13:28:34Z</dcterms:modified>
</cp:coreProperties>
</file>